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7" r:id="rId2"/>
  </p:sldIdLst>
  <p:sldSz cx="19440525" cy="10206038"/>
  <p:notesSz cx="6858000" cy="9144000"/>
  <p:defaultTextStyle>
    <a:defPPr>
      <a:defRPr lang="ja-JP"/>
    </a:defPPr>
    <a:lvl1pPr marL="0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1pPr>
    <a:lvl2pPr marL="926196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2pPr>
    <a:lvl3pPr marL="1852392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3pPr>
    <a:lvl4pPr marL="2778587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4pPr>
    <a:lvl5pPr marL="3704783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5pPr>
    <a:lvl6pPr marL="4630979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6pPr>
    <a:lvl7pPr marL="5557175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7pPr>
    <a:lvl8pPr marL="6483370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8pPr>
    <a:lvl9pPr marL="7409566" algn="l" defTabSz="1852392" rtl="0" eaLnBrk="1" latinLnBrk="0" hangingPunct="1">
      <a:defRPr kumimoji="1" sz="364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632" userDrawn="1">
          <p15:clr>
            <a:srgbClr val="A4A3A4"/>
          </p15:clr>
        </p15:guide>
        <p15:guide id="3" orient="horz" pos="4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4081"/>
    <a:srgbClr val="FD808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94624"/>
  </p:normalViewPr>
  <p:slideViewPr>
    <p:cSldViewPr snapToGrid="0" snapToObjects="1">
      <p:cViewPr varScale="1">
        <p:scale>
          <a:sx n="71" d="100"/>
          <a:sy n="71" d="100"/>
        </p:scale>
        <p:origin x="1064" y="192"/>
      </p:cViewPr>
      <p:guideLst>
        <p:guide pos="1632"/>
        <p:guide orient="horz" pos="4880"/>
      </p:guideLst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593A1-12CC-3A42-80DD-40D606503965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90538" y="1143000"/>
            <a:ext cx="5876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4FA682-46A4-E548-A0C1-E8412D259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727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30066" y="1670295"/>
            <a:ext cx="14580394" cy="3553213"/>
          </a:xfrm>
        </p:spPr>
        <p:txBody>
          <a:bodyPr anchor="b"/>
          <a:lstStyle>
            <a:lvl1pPr algn="ctr">
              <a:defRPr sz="892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30066" y="5360533"/>
            <a:ext cx="14580394" cy="2464096"/>
          </a:xfrm>
        </p:spPr>
        <p:txBody>
          <a:bodyPr/>
          <a:lstStyle>
            <a:lvl1pPr marL="0" indent="0" algn="ctr">
              <a:buNone/>
              <a:defRPr sz="3572"/>
            </a:lvl1pPr>
            <a:lvl2pPr marL="680405" indent="0" algn="ctr">
              <a:buNone/>
              <a:defRPr sz="2976"/>
            </a:lvl2pPr>
            <a:lvl3pPr marL="1360810" indent="0" algn="ctr">
              <a:buNone/>
              <a:defRPr sz="2679"/>
            </a:lvl3pPr>
            <a:lvl4pPr marL="2041215" indent="0" algn="ctr">
              <a:buNone/>
              <a:defRPr sz="2381"/>
            </a:lvl4pPr>
            <a:lvl5pPr marL="2721620" indent="0" algn="ctr">
              <a:buNone/>
              <a:defRPr sz="2381"/>
            </a:lvl5pPr>
            <a:lvl6pPr marL="3402025" indent="0" algn="ctr">
              <a:buNone/>
              <a:defRPr sz="2381"/>
            </a:lvl6pPr>
            <a:lvl7pPr marL="4082430" indent="0" algn="ctr">
              <a:buNone/>
              <a:defRPr sz="2381"/>
            </a:lvl7pPr>
            <a:lvl8pPr marL="4762835" indent="0" algn="ctr">
              <a:buNone/>
              <a:defRPr sz="2381"/>
            </a:lvl8pPr>
            <a:lvl9pPr marL="5443240" indent="0" algn="ctr">
              <a:buNone/>
              <a:defRPr sz="238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634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875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912126" y="543377"/>
            <a:ext cx="4191863" cy="864914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36536" y="543377"/>
            <a:ext cx="12332583" cy="864914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85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14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6411" y="2544423"/>
            <a:ext cx="16767453" cy="4245428"/>
          </a:xfrm>
        </p:spPr>
        <p:txBody>
          <a:bodyPr anchor="b"/>
          <a:lstStyle>
            <a:lvl1pPr>
              <a:defRPr sz="892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6411" y="6830014"/>
            <a:ext cx="16767453" cy="2232570"/>
          </a:xfrm>
        </p:spPr>
        <p:txBody>
          <a:bodyPr/>
          <a:lstStyle>
            <a:lvl1pPr marL="0" indent="0">
              <a:buNone/>
              <a:defRPr sz="3572">
                <a:solidFill>
                  <a:schemeClr val="tx1">
                    <a:tint val="75000"/>
                  </a:schemeClr>
                </a:solidFill>
              </a:defRPr>
            </a:lvl1pPr>
            <a:lvl2pPr marL="680405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2pPr>
            <a:lvl3pPr marL="1360810" indent="0">
              <a:buNone/>
              <a:defRPr sz="2679">
                <a:solidFill>
                  <a:schemeClr val="tx1">
                    <a:tint val="75000"/>
                  </a:schemeClr>
                </a:solidFill>
              </a:defRPr>
            </a:lvl3pPr>
            <a:lvl4pPr marL="2041215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4pPr>
            <a:lvl5pPr marL="2721620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5pPr>
            <a:lvl6pPr marL="3402025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6pPr>
            <a:lvl7pPr marL="4082430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7pPr>
            <a:lvl8pPr marL="4762835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8pPr>
            <a:lvl9pPr marL="5443240" indent="0">
              <a:buNone/>
              <a:defRPr sz="238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205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6536" y="2716885"/>
            <a:ext cx="8262223" cy="64756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841766" y="2716885"/>
            <a:ext cx="8262223" cy="64756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058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068" y="543378"/>
            <a:ext cx="16767453" cy="197269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9069" y="2501898"/>
            <a:ext cx="8224253" cy="1226141"/>
          </a:xfrm>
        </p:spPr>
        <p:txBody>
          <a:bodyPr anchor="b"/>
          <a:lstStyle>
            <a:lvl1pPr marL="0" indent="0">
              <a:buNone/>
              <a:defRPr sz="3572" b="1"/>
            </a:lvl1pPr>
            <a:lvl2pPr marL="680405" indent="0">
              <a:buNone/>
              <a:defRPr sz="2976" b="1"/>
            </a:lvl2pPr>
            <a:lvl3pPr marL="1360810" indent="0">
              <a:buNone/>
              <a:defRPr sz="2679" b="1"/>
            </a:lvl3pPr>
            <a:lvl4pPr marL="2041215" indent="0">
              <a:buNone/>
              <a:defRPr sz="2381" b="1"/>
            </a:lvl4pPr>
            <a:lvl5pPr marL="2721620" indent="0">
              <a:buNone/>
              <a:defRPr sz="2381" b="1"/>
            </a:lvl5pPr>
            <a:lvl6pPr marL="3402025" indent="0">
              <a:buNone/>
              <a:defRPr sz="2381" b="1"/>
            </a:lvl6pPr>
            <a:lvl7pPr marL="4082430" indent="0">
              <a:buNone/>
              <a:defRPr sz="2381" b="1"/>
            </a:lvl7pPr>
            <a:lvl8pPr marL="4762835" indent="0">
              <a:buNone/>
              <a:defRPr sz="2381" b="1"/>
            </a:lvl8pPr>
            <a:lvl9pPr marL="5443240" indent="0">
              <a:buNone/>
              <a:defRPr sz="2381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9069" y="3728039"/>
            <a:ext cx="8224253" cy="54833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841766" y="2501898"/>
            <a:ext cx="8264755" cy="1226141"/>
          </a:xfrm>
        </p:spPr>
        <p:txBody>
          <a:bodyPr anchor="b"/>
          <a:lstStyle>
            <a:lvl1pPr marL="0" indent="0">
              <a:buNone/>
              <a:defRPr sz="3572" b="1"/>
            </a:lvl1pPr>
            <a:lvl2pPr marL="680405" indent="0">
              <a:buNone/>
              <a:defRPr sz="2976" b="1"/>
            </a:lvl2pPr>
            <a:lvl3pPr marL="1360810" indent="0">
              <a:buNone/>
              <a:defRPr sz="2679" b="1"/>
            </a:lvl3pPr>
            <a:lvl4pPr marL="2041215" indent="0">
              <a:buNone/>
              <a:defRPr sz="2381" b="1"/>
            </a:lvl4pPr>
            <a:lvl5pPr marL="2721620" indent="0">
              <a:buNone/>
              <a:defRPr sz="2381" b="1"/>
            </a:lvl5pPr>
            <a:lvl6pPr marL="3402025" indent="0">
              <a:buNone/>
              <a:defRPr sz="2381" b="1"/>
            </a:lvl6pPr>
            <a:lvl7pPr marL="4082430" indent="0">
              <a:buNone/>
              <a:defRPr sz="2381" b="1"/>
            </a:lvl7pPr>
            <a:lvl8pPr marL="4762835" indent="0">
              <a:buNone/>
              <a:defRPr sz="2381" b="1"/>
            </a:lvl8pPr>
            <a:lvl9pPr marL="5443240" indent="0">
              <a:buNone/>
              <a:defRPr sz="2381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841766" y="3728039"/>
            <a:ext cx="8264755" cy="54833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252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277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8734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069" y="680402"/>
            <a:ext cx="6270075" cy="2381409"/>
          </a:xfrm>
        </p:spPr>
        <p:txBody>
          <a:bodyPr anchor="b"/>
          <a:lstStyle>
            <a:lvl1pPr>
              <a:defRPr sz="476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264755" y="1469481"/>
            <a:ext cx="9841766" cy="7252902"/>
          </a:xfrm>
        </p:spPr>
        <p:txBody>
          <a:bodyPr/>
          <a:lstStyle>
            <a:lvl1pPr>
              <a:defRPr sz="4762"/>
            </a:lvl1pPr>
            <a:lvl2pPr>
              <a:defRPr sz="4167"/>
            </a:lvl2pPr>
            <a:lvl3pPr>
              <a:defRPr sz="3572"/>
            </a:lvl3pPr>
            <a:lvl4pPr>
              <a:defRPr sz="2976"/>
            </a:lvl4pPr>
            <a:lvl5pPr>
              <a:defRPr sz="2976"/>
            </a:lvl5pPr>
            <a:lvl6pPr>
              <a:defRPr sz="2976"/>
            </a:lvl6pPr>
            <a:lvl7pPr>
              <a:defRPr sz="2976"/>
            </a:lvl7pPr>
            <a:lvl8pPr>
              <a:defRPr sz="2976"/>
            </a:lvl8pPr>
            <a:lvl9pPr>
              <a:defRPr sz="2976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9069" y="3061812"/>
            <a:ext cx="6270075" cy="5672384"/>
          </a:xfrm>
        </p:spPr>
        <p:txBody>
          <a:bodyPr/>
          <a:lstStyle>
            <a:lvl1pPr marL="0" indent="0">
              <a:buNone/>
              <a:defRPr sz="2381"/>
            </a:lvl1pPr>
            <a:lvl2pPr marL="680405" indent="0">
              <a:buNone/>
              <a:defRPr sz="2083"/>
            </a:lvl2pPr>
            <a:lvl3pPr marL="1360810" indent="0">
              <a:buNone/>
              <a:defRPr sz="1786"/>
            </a:lvl3pPr>
            <a:lvl4pPr marL="2041215" indent="0">
              <a:buNone/>
              <a:defRPr sz="1488"/>
            </a:lvl4pPr>
            <a:lvl5pPr marL="2721620" indent="0">
              <a:buNone/>
              <a:defRPr sz="1488"/>
            </a:lvl5pPr>
            <a:lvl6pPr marL="3402025" indent="0">
              <a:buNone/>
              <a:defRPr sz="1488"/>
            </a:lvl6pPr>
            <a:lvl7pPr marL="4082430" indent="0">
              <a:buNone/>
              <a:defRPr sz="1488"/>
            </a:lvl7pPr>
            <a:lvl8pPr marL="4762835" indent="0">
              <a:buNone/>
              <a:defRPr sz="1488"/>
            </a:lvl8pPr>
            <a:lvl9pPr marL="5443240" indent="0">
              <a:buNone/>
              <a:defRPr sz="148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44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9069" y="680402"/>
            <a:ext cx="6270075" cy="2381409"/>
          </a:xfrm>
        </p:spPr>
        <p:txBody>
          <a:bodyPr anchor="b"/>
          <a:lstStyle>
            <a:lvl1pPr>
              <a:defRPr sz="476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264755" y="1469481"/>
            <a:ext cx="9841766" cy="7252902"/>
          </a:xfrm>
        </p:spPr>
        <p:txBody>
          <a:bodyPr anchor="t"/>
          <a:lstStyle>
            <a:lvl1pPr marL="0" indent="0">
              <a:buNone/>
              <a:defRPr sz="4762"/>
            </a:lvl1pPr>
            <a:lvl2pPr marL="680405" indent="0">
              <a:buNone/>
              <a:defRPr sz="4167"/>
            </a:lvl2pPr>
            <a:lvl3pPr marL="1360810" indent="0">
              <a:buNone/>
              <a:defRPr sz="3572"/>
            </a:lvl3pPr>
            <a:lvl4pPr marL="2041215" indent="0">
              <a:buNone/>
              <a:defRPr sz="2976"/>
            </a:lvl4pPr>
            <a:lvl5pPr marL="2721620" indent="0">
              <a:buNone/>
              <a:defRPr sz="2976"/>
            </a:lvl5pPr>
            <a:lvl6pPr marL="3402025" indent="0">
              <a:buNone/>
              <a:defRPr sz="2976"/>
            </a:lvl6pPr>
            <a:lvl7pPr marL="4082430" indent="0">
              <a:buNone/>
              <a:defRPr sz="2976"/>
            </a:lvl7pPr>
            <a:lvl8pPr marL="4762835" indent="0">
              <a:buNone/>
              <a:defRPr sz="2976"/>
            </a:lvl8pPr>
            <a:lvl9pPr marL="5443240" indent="0">
              <a:buNone/>
              <a:defRPr sz="297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9069" y="3061812"/>
            <a:ext cx="6270075" cy="5672384"/>
          </a:xfrm>
        </p:spPr>
        <p:txBody>
          <a:bodyPr/>
          <a:lstStyle>
            <a:lvl1pPr marL="0" indent="0">
              <a:buNone/>
              <a:defRPr sz="2381"/>
            </a:lvl1pPr>
            <a:lvl2pPr marL="680405" indent="0">
              <a:buNone/>
              <a:defRPr sz="2083"/>
            </a:lvl2pPr>
            <a:lvl3pPr marL="1360810" indent="0">
              <a:buNone/>
              <a:defRPr sz="1786"/>
            </a:lvl3pPr>
            <a:lvl4pPr marL="2041215" indent="0">
              <a:buNone/>
              <a:defRPr sz="1488"/>
            </a:lvl4pPr>
            <a:lvl5pPr marL="2721620" indent="0">
              <a:buNone/>
              <a:defRPr sz="1488"/>
            </a:lvl5pPr>
            <a:lvl6pPr marL="3402025" indent="0">
              <a:buNone/>
              <a:defRPr sz="1488"/>
            </a:lvl6pPr>
            <a:lvl7pPr marL="4082430" indent="0">
              <a:buNone/>
              <a:defRPr sz="1488"/>
            </a:lvl7pPr>
            <a:lvl8pPr marL="4762835" indent="0">
              <a:buNone/>
              <a:defRPr sz="1488"/>
            </a:lvl8pPr>
            <a:lvl9pPr marL="5443240" indent="0">
              <a:buNone/>
              <a:defRPr sz="148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178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36536" y="543378"/>
            <a:ext cx="16767453" cy="19726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6536" y="2716885"/>
            <a:ext cx="16767453" cy="64756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36536" y="9459486"/>
            <a:ext cx="4374118" cy="5433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39C29-CB5A-744F-B896-A24BBF9E6DEB}" type="datetimeFigureOut">
              <a:rPr kumimoji="1" lang="ja-JP" altLang="en-US" smtClean="0"/>
              <a:t>2023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439674" y="9459486"/>
            <a:ext cx="6561177" cy="5433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729871" y="9459486"/>
            <a:ext cx="4374118" cy="5433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05FA4-A9FC-F648-8CE5-5BA220ED64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362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60810" rtl="0" eaLnBrk="1" latinLnBrk="0" hangingPunct="1">
        <a:lnSpc>
          <a:spcPct val="90000"/>
        </a:lnSpc>
        <a:spcBef>
          <a:spcPct val="0"/>
        </a:spcBef>
        <a:buNone/>
        <a:defRPr kumimoji="1" sz="65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0203" indent="-340203" algn="l" defTabSz="1360810" rtl="0" eaLnBrk="1" latinLnBrk="0" hangingPunct="1">
        <a:lnSpc>
          <a:spcPct val="90000"/>
        </a:lnSpc>
        <a:spcBef>
          <a:spcPts val="1488"/>
        </a:spcBef>
        <a:buFont typeface="Arial" panose="020B0604020202020204" pitchFamily="34" charset="0"/>
        <a:buChar char="•"/>
        <a:defRPr kumimoji="1" sz="4167" kern="1200">
          <a:solidFill>
            <a:schemeClr val="tx1"/>
          </a:solidFill>
          <a:latin typeface="+mn-lt"/>
          <a:ea typeface="+mn-ea"/>
          <a:cs typeface="+mn-cs"/>
        </a:defRPr>
      </a:lvl1pPr>
      <a:lvl2pPr marL="1020608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3572" kern="1200">
          <a:solidFill>
            <a:schemeClr val="tx1"/>
          </a:solidFill>
          <a:latin typeface="+mn-lt"/>
          <a:ea typeface="+mn-ea"/>
          <a:cs typeface="+mn-cs"/>
        </a:defRPr>
      </a:lvl2pPr>
      <a:lvl3pPr marL="1701013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381418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4pPr>
      <a:lvl5pPr marL="3061823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5pPr>
      <a:lvl6pPr marL="3742228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6pPr>
      <a:lvl7pPr marL="4422633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7pPr>
      <a:lvl8pPr marL="5103038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8pPr>
      <a:lvl9pPr marL="5783443" indent="-340203" algn="l" defTabSz="1360810" rtl="0" eaLnBrk="1" latinLnBrk="0" hangingPunct="1">
        <a:lnSpc>
          <a:spcPct val="90000"/>
        </a:lnSpc>
        <a:spcBef>
          <a:spcPts val="744"/>
        </a:spcBef>
        <a:buFont typeface="Arial" panose="020B0604020202020204" pitchFamily="34" charset="0"/>
        <a:buChar char="•"/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1pPr>
      <a:lvl2pPr marL="680405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2pPr>
      <a:lvl3pPr marL="1360810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3pPr>
      <a:lvl4pPr marL="2041215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4pPr>
      <a:lvl5pPr marL="2721620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5pPr>
      <a:lvl6pPr marL="3402025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6pPr>
      <a:lvl7pPr marL="4082430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7pPr>
      <a:lvl8pPr marL="4762835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8pPr>
      <a:lvl9pPr marL="5443240" algn="l" defTabSz="1360810" rtl="0" eaLnBrk="1" latinLnBrk="0" hangingPunct="1">
        <a:defRPr kumimoji="1" sz="26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>
            <a:extLst>
              <a:ext uri="{FF2B5EF4-FFF2-40B4-BE49-F238E27FC236}">
                <a16:creationId xmlns:a16="http://schemas.microsoft.com/office/drawing/2014/main" id="{E5107BE2-9D5F-CD4B-8C7E-67682B06405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19" r="1411" b="4101"/>
          <a:stretch/>
        </p:blipFill>
        <p:spPr bwMode="auto">
          <a:xfrm>
            <a:off x="1472731" y="416473"/>
            <a:ext cx="16080163" cy="795763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698381E-0FE6-6B4E-8C50-BD92B45F9CC3}"/>
              </a:ext>
            </a:extLst>
          </p:cNvPr>
          <p:cNvSpPr txBox="1"/>
          <p:nvPr/>
        </p:nvSpPr>
        <p:spPr>
          <a:xfrm>
            <a:off x="1255058" y="8374111"/>
            <a:ext cx="1748081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000" dirty="0"/>
              <a:t>Supplemental material 5: Enhancement of rate-limiting enzymes of glycolysis and the TCA cycle in macrophage </a:t>
            </a:r>
          </a:p>
          <a:p>
            <a:r>
              <a:rPr lang="ja-JP" altLang="en-US" sz="3000"/>
              <a:t>　　　　　　　　</a:t>
            </a:r>
            <a:r>
              <a:rPr lang="en-US" altLang="ja-JP" sz="3000" dirty="0"/>
              <a:t>           </a:t>
            </a:r>
            <a:r>
              <a:rPr kumimoji="1" lang="en-US" altLang="ja-JP" sz="3000" dirty="0"/>
              <a:t>by skeletal myotube-derived extracellular vesicles.</a:t>
            </a:r>
            <a:endParaRPr kumimoji="1" lang="ja-JP" altLang="en-US" sz="3000"/>
          </a:p>
        </p:txBody>
      </p:sp>
    </p:spTree>
    <p:extLst>
      <p:ext uri="{BB962C8B-B14F-4D97-AF65-F5344CB8AC3E}">
        <p14:creationId xmlns:p14="http://schemas.microsoft.com/office/powerpoint/2010/main" val="1158396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48</TotalTime>
  <Words>31</Words>
  <Application>Microsoft Macintosh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63</cp:revision>
  <cp:lastPrinted>2023-01-31T15:54:42Z</cp:lastPrinted>
  <dcterms:created xsi:type="dcterms:W3CDTF">2022-07-16T11:52:01Z</dcterms:created>
  <dcterms:modified xsi:type="dcterms:W3CDTF">2023-02-01T08:20:39Z</dcterms:modified>
</cp:coreProperties>
</file>